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53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E3DB3B7-C585-22EC-DC54-10CF29E07FD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5FE15D5-BA64-E9F2-E2A8-66BBA6A007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5148C74-4AEF-89E9-0C33-102BB08271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06F54-8F1C-4116-8849-8CE81FFE7959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5E8C8D2-98AC-08F6-6F6E-61000D53FD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A79286F-3AA8-79E4-528E-3D7C3FBA66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9BAB6-C48E-43DA-9B40-59AC0762C5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13106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43F63A-FC8E-75A7-A7C8-0E19AB08EF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9034753-3410-C7F3-147B-E1E9CFEC9F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B9AE0CE-7B75-049D-491E-1A83617395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06F54-8F1C-4116-8849-8CE81FFE7959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65BE037-5F1B-273D-35C4-B2F5121B27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9EFC387-B35B-E996-5B0A-F91D49843A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9BAB6-C48E-43DA-9B40-59AC0762C5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2112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2C81FC2-B021-219E-0D47-9192DFAE41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79C066A-32C5-FB9B-D489-7721C47EF8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67BFC26-49C3-E5FF-9832-BEF7B952B8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06F54-8F1C-4116-8849-8CE81FFE7959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926D3D7-5856-4E85-4912-C04B2BCDB7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D5AF029-E6E2-18ED-F3D1-7708B3126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9BAB6-C48E-43DA-9B40-59AC0762C5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8914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04E1C34-124B-5CF3-6F40-82D0C03940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88668A9-F43E-9D0A-9C29-3BF9F7F4A1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88133E2-72D5-C7F8-8A10-33FB6E2EAA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06F54-8F1C-4116-8849-8CE81FFE7959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987BC5C-7701-4064-CB53-5BCF04748D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6E36070-8E56-C867-59DA-0DA22C397F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9BAB6-C48E-43DA-9B40-59AC0762C5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7318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2D6D4F9-8AE2-2D30-92F3-384518F747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8E81726-F576-4754-E498-142B86FFB2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A559FDC-E9BE-03F5-ECB6-20F23A6416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06F54-8F1C-4116-8849-8CE81FFE7959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87093D3-97F0-D0EB-A38A-B1E239B8D9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8FCF6FB-3291-061B-4AD4-9EF3F62F67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9BAB6-C48E-43DA-9B40-59AC0762C5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88973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034BD10-0B80-64F6-3356-C80422BE30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74607BD-99AA-E917-188F-13C063CF633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7D6481B-0ABC-EC1E-0B58-22251F95E2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3670F09-E535-96D6-8244-7FE5C9B526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06F54-8F1C-4116-8849-8CE81FFE7959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6250B39-ADA4-BABC-7A70-4AA2CBA8BC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6581870-1360-C2D1-DDCA-D6DB987C37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9BAB6-C48E-43DA-9B40-59AC0762C5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08629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7AA84BD-DD4D-D073-C6C0-8AD39FA595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5857633-E23F-DFE8-FC1E-E9068E0CC1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93AAFF6-19AA-BEB3-5B36-5CC37B6426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9AE658D-336A-3020-7980-D20FDA1DE1F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2193301-5EFA-DDEE-82F0-A65FB55674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2EDD70D-93C9-8BE4-7086-479BBBA98A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06F54-8F1C-4116-8849-8CE81FFE7959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922AE1E-A3C2-CDFE-22D4-54B9A70C70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3D3F61D-C1D9-38FA-8F42-19E3A3F180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9BAB6-C48E-43DA-9B40-59AC0762C5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95087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C98704E-A0EA-DC39-2A11-CF990E0B37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0B5B6EE-978E-FBAF-4EBC-2CED103D27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06F54-8F1C-4116-8849-8CE81FFE7959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D327363-D8FB-3327-335F-72E44A05CD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D7143E5-DA07-1EE5-A86E-3C835B0C0A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9BAB6-C48E-43DA-9B40-59AC0762C5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0465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CE18CDC-BBCD-A27F-B5FE-E0C6DB6692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06F54-8F1C-4116-8849-8CE81FFE7959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7E8849A6-2D4F-73D7-F523-035F861650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F130A36-2ACE-E3AD-D9F4-726FB4BEEB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9BAB6-C48E-43DA-9B40-59AC0762C5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27842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B859E67-B91D-D906-8112-A60C8279B2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8619666-ECDF-B552-75E2-126D903BF3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C7310C6-F0EE-37E2-E478-A871559743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40296E4-CF12-E1F5-ABD0-1FC8A68A94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06F54-8F1C-4116-8849-8CE81FFE7959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29BD015-9F40-B277-9636-AF286C26E3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45BD67B-7CB4-9CB3-1451-D9B65A4378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9BAB6-C48E-43DA-9B40-59AC0762C5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07832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0F77998-F88A-3E96-5D9B-57E3C7A4C9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0E9A0E2-2ACF-9BEB-3E13-BF6919CE75D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EE0CF13-8088-0456-89F3-5D66C8C07C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BDD6AD9-30DB-69C2-BE1F-D3791E119D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06F54-8F1C-4116-8849-8CE81FFE7959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E0EB7C4-68CA-B439-DB3B-765E5E6A9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38F9C34-B85B-E582-7F44-C83E3DC578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9BAB6-C48E-43DA-9B40-59AC0762C5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80219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31F3B16-F069-3B11-1DB6-07AF6A9379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A7B571E-E8CA-80A6-1608-AD77ABCB26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8BABF28-5B13-CC34-A165-C2E062309C8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8106F54-8F1C-4116-8849-8CE81FFE7959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D7DE1FF-52F1-896E-3FAA-20D196DCE6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B011AF7-4D15-32D0-BB3C-986208C558D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799BAB6-C48E-43DA-9B40-59AC0762C5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73847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F6D9A4-CD94-2EB9-E966-208D184CCACD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D6C4E90-9D69-BFC8-0E36-106B3D856946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D610D943-D33B-9391-A72A-6C1C7E3CE28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90447493"/>
              </p:ext>
            </p:extLst>
          </p:nvPr>
        </p:nvGraphicFramePr>
        <p:xfrm>
          <a:off x="696685" y="255814"/>
          <a:ext cx="11048999" cy="6346371"/>
        </p:xfrm>
        <a:graphic>
          <a:graphicData uri="http://schemas.openxmlformats.org/drawingml/2006/table">
            <a:tbl>
              <a:tblPr/>
              <a:tblGrid>
                <a:gridCol w="952119">
                  <a:extLst>
                    <a:ext uri="{9D8B030D-6E8A-4147-A177-3AD203B41FA5}">
                      <a16:colId xmlns:a16="http://schemas.microsoft.com/office/drawing/2014/main" val="909158818"/>
                    </a:ext>
                  </a:extLst>
                </a:gridCol>
                <a:gridCol w="631055">
                  <a:extLst>
                    <a:ext uri="{9D8B030D-6E8A-4147-A177-3AD203B41FA5}">
                      <a16:colId xmlns:a16="http://schemas.microsoft.com/office/drawing/2014/main" val="720178827"/>
                    </a:ext>
                  </a:extLst>
                </a:gridCol>
                <a:gridCol w="631055">
                  <a:extLst>
                    <a:ext uri="{9D8B030D-6E8A-4147-A177-3AD203B41FA5}">
                      <a16:colId xmlns:a16="http://schemas.microsoft.com/office/drawing/2014/main" val="2212131540"/>
                    </a:ext>
                  </a:extLst>
                </a:gridCol>
                <a:gridCol w="631055">
                  <a:extLst>
                    <a:ext uri="{9D8B030D-6E8A-4147-A177-3AD203B41FA5}">
                      <a16:colId xmlns:a16="http://schemas.microsoft.com/office/drawing/2014/main" val="76463832"/>
                    </a:ext>
                  </a:extLst>
                </a:gridCol>
                <a:gridCol w="631055">
                  <a:extLst>
                    <a:ext uri="{9D8B030D-6E8A-4147-A177-3AD203B41FA5}">
                      <a16:colId xmlns:a16="http://schemas.microsoft.com/office/drawing/2014/main" val="2178649145"/>
                    </a:ext>
                  </a:extLst>
                </a:gridCol>
                <a:gridCol w="631055">
                  <a:extLst>
                    <a:ext uri="{9D8B030D-6E8A-4147-A177-3AD203B41FA5}">
                      <a16:colId xmlns:a16="http://schemas.microsoft.com/office/drawing/2014/main" val="2577855754"/>
                    </a:ext>
                  </a:extLst>
                </a:gridCol>
                <a:gridCol w="631055">
                  <a:extLst>
                    <a:ext uri="{9D8B030D-6E8A-4147-A177-3AD203B41FA5}">
                      <a16:colId xmlns:a16="http://schemas.microsoft.com/office/drawing/2014/main" val="1851248064"/>
                    </a:ext>
                  </a:extLst>
                </a:gridCol>
                <a:gridCol w="631055">
                  <a:extLst>
                    <a:ext uri="{9D8B030D-6E8A-4147-A177-3AD203B41FA5}">
                      <a16:colId xmlns:a16="http://schemas.microsoft.com/office/drawing/2014/main" val="917294762"/>
                    </a:ext>
                  </a:extLst>
                </a:gridCol>
                <a:gridCol w="631055">
                  <a:extLst>
                    <a:ext uri="{9D8B030D-6E8A-4147-A177-3AD203B41FA5}">
                      <a16:colId xmlns:a16="http://schemas.microsoft.com/office/drawing/2014/main" val="3640142024"/>
                    </a:ext>
                  </a:extLst>
                </a:gridCol>
                <a:gridCol w="631055">
                  <a:extLst>
                    <a:ext uri="{9D8B030D-6E8A-4147-A177-3AD203B41FA5}">
                      <a16:colId xmlns:a16="http://schemas.microsoft.com/office/drawing/2014/main" val="3264574963"/>
                    </a:ext>
                  </a:extLst>
                </a:gridCol>
                <a:gridCol w="631055">
                  <a:extLst>
                    <a:ext uri="{9D8B030D-6E8A-4147-A177-3AD203B41FA5}">
                      <a16:colId xmlns:a16="http://schemas.microsoft.com/office/drawing/2014/main" val="3209024739"/>
                    </a:ext>
                  </a:extLst>
                </a:gridCol>
                <a:gridCol w="631055">
                  <a:extLst>
                    <a:ext uri="{9D8B030D-6E8A-4147-A177-3AD203B41FA5}">
                      <a16:colId xmlns:a16="http://schemas.microsoft.com/office/drawing/2014/main" val="2595693371"/>
                    </a:ext>
                  </a:extLst>
                </a:gridCol>
                <a:gridCol w="631055">
                  <a:extLst>
                    <a:ext uri="{9D8B030D-6E8A-4147-A177-3AD203B41FA5}">
                      <a16:colId xmlns:a16="http://schemas.microsoft.com/office/drawing/2014/main" val="2626662069"/>
                    </a:ext>
                  </a:extLst>
                </a:gridCol>
                <a:gridCol w="631055">
                  <a:extLst>
                    <a:ext uri="{9D8B030D-6E8A-4147-A177-3AD203B41FA5}">
                      <a16:colId xmlns:a16="http://schemas.microsoft.com/office/drawing/2014/main" val="1071822274"/>
                    </a:ext>
                  </a:extLst>
                </a:gridCol>
                <a:gridCol w="631055">
                  <a:extLst>
                    <a:ext uri="{9D8B030D-6E8A-4147-A177-3AD203B41FA5}">
                      <a16:colId xmlns:a16="http://schemas.microsoft.com/office/drawing/2014/main" val="294670142"/>
                    </a:ext>
                  </a:extLst>
                </a:gridCol>
                <a:gridCol w="631055">
                  <a:extLst>
                    <a:ext uri="{9D8B030D-6E8A-4147-A177-3AD203B41FA5}">
                      <a16:colId xmlns:a16="http://schemas.microsoft.com/office/drawing/2014/main" val="2380495344"/>
                    </a:ext>
                  </a:extLst>
                </a:gridCol>
                <a:gridCol w="631055">
                  <a:extLst>
                    <a:ext uri="{9D8B030D-6E8A-4147-A177-3AD203B41FA5}">
                      <a16:colId xmlns:a16="http://schemas.microsoft.com/office/drawing/2014/main" val="1366170989"/>
                    </a:ext>
                  </a:extLst>
                </a:gridCol>
              </a:tblGrid>
              <a:tr h="509588">
                <a:tc gridSpan="17"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upplementally table 4.Association between modified cumulative number of ACEs and risk of death stratified by gender (modified Poisson regression model n=1,1734)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18549956"/>
                  </a:ext>
                </a:extLst>
              </a:tr>
              <a:tr h="2608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en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71612403"/>
                  </a:ext>
                </a:extLst>
              </a:tr>
              <a:tr h="269577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umber of ACEs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rude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1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2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3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74994982"/>
                  </a:ext>
                </a:extLst>
              </a:tr>
              <a:tr h="269577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2834071"/>
                  </a:ext>
                </a:extLst>
              </a:tr>
              <a:tr h="26957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6020856"/>
                  </a:ext>
                </a:extLst>
              </a:tr>
              <a:tr h="26957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5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0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42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0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7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4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43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6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4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0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352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7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4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1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308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0804047"/>
                  </a:ext>
                </a:extLst>
              </a:tr>
              <a:tr h="26957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+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30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64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23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98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44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74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76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5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47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78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6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52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7339187"/>
                  </a:ext>
                </a:extLst>
              </a:tr>
              <a:tr h="2695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Women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6482999"/>
                  </a:ext>
                </a:extLst>
              </a:tr>
              <a:tr h="269577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umber of ACEs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rude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1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2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3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61894817"/>
                  </a:ext>
                </a:extLst>
              </a:tr>
              <a:tr h="269577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34059002"/>
                  </a:ext>
                </a:extLst>
              </a:tr>
              <a:tr h="26957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f.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5550787"/>
                  </a:ext>
                </a:extLst>
              </a:tr>
              <a:tr h="26957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46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3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74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0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1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43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37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7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8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39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77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7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8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39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78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43020646"/>
                  </a:ext>
                </a:extLst>
              </a:tr>
              <a:tr h="26957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+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82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1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17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76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7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7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67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72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6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9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03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98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7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9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08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12</a:t>
                      </a:r>
                    </a:p>
                  </a:txBody>
                  <a:tcPr marL="5962" marR="5962" marT="59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17346275"/>
                  </a:ext>
                </a:extLst>
              </a:tr>
              <a:tr h="509588">
                <a:tc gridSpan="17"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ote. Controlled for age, childhood economical hardship, height, education, equivalized income, longest occupation, smoing, drinking, Disease, depressive symptom, martial status, frequency of meeting friends, social participation, employment status.   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63787431"/>
                  </a:ext>
                </a:extLst>
              </a:tr>
              <a:tr h="269577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rude includes cumulative ACEs score 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56414092"/>
                  </a:ext>
                </a:extLst>
              </a:tr>
              <a:tr h="539156">
                <a:tc gridSpan="17"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 1 Includes Crude Model and age and adverse childhood experiences (economic status in childhood, height, educational history) and socioeconomic status in old age (equivalized income, employment status).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4172162"/>
                  </a:ext>
                </a:extLst>
              </a:tr>
              <a:tr h="509588">
                <a:tc gridSpan="17"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 2 includes Model 2 and health status in old age (hypertension, diabetes, dyslipidemia, heart disease, respiratory disease, cancer) and lifestyle (smoking and alcohol).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19680503"/>
                  </a:ext>
                </a:extLst>
              </a:tr>
              <a:tr h="513067">
                <a:tc gridSpan="17"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 3 includes Model 3 and social relationships in old age (social participation, frequency of interaction with friends, employment status, marital status). 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14993247"/>
                  </a:ext>
                </a:extLst>
              </a:tr>
              <a:tr h="269577">
                <a:tc gridSpan="11"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CEs: Adverse Childhood Experiences, IRR: Incidence Rate Ratio, CI: Confidence Interval  </a:t>
                      </a: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962" marR="5962" marT="5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234656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559169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65</Words>
  <Application>Microsoft Office PowerPoint</Application>
  <PresentationFormat>ワイド画面</PresentationFormat>
  <Paragraphs>13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巌 千嶋</dc:creator>
  <cp:lastModifiedBy>巌 千嶋</cp:lastModifiedBy>
  <cp:revision>1</cp:revision>
  <dcterms:created xsi:type="dcterms:W3CDTF">2024-11-03T05:45:35Z</dcterms:created>
  <dcterms:modified xsi:type="dcterms:W3CDTF">2024-11-03T05:47:04Z</dcterms:modified>
</cp:coreProperties>
</file>